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1"/>
    <p:restoredTop sz="96327"/>
  </p:normalViewPr>
  <p:slideViewPr>
    <p:cSldViewPr snapToGrid="0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12D6F9-5DCC-E045-91C6-0291FB4C8008}" type="datetimeFigureOut">
              <a:rPr lang="en-US" smtClean="0"/>
              <a:t>4/12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942504-B363-E840-80CF-7FC47D3B7A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8247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DBDC91C-1552-6E47-8464-2D5A4C5D201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4196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8AA18D-EB1E-3F36-9B96-FD31ECA32B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F5867D5-EC52-3418-9874-F39A500580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E1101C-9E08-8E8A-C38F-49265BDED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79029-DFE4-244A-8A88-9AB034AAA29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FD9CB0-B899-0361-04A3-011DB33B32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161C44-B1BA-3DE0-4452-839685BE47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C2354-642A-4046-BEB0-DFD3439D96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381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56E92A-C053-FCF3-3896-9298B854FF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FD01AB-2FD0-80B3-24BF-FF7EAC57E9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7141F1-8DCD-53C7-95D9-9BC7C63B62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79029-DFE4-244A-8A88-9AB034AAA29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9A474B-E240-2C07-C61B-1E21F81876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539433-BAD1-8A50-2A0E-6DF360C55C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C2354-642A-4046-BEB0-DFD3439D96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9956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F0CC98B-267F-0FCC-9CC7-FD1B3F1BE2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25371EE-766E-FE9C-DF2B-816078155E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284F90-200B-64B2-EE7B-490229C430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79029-DFE4-244A-8A88-9AB034AAA29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B0C420-B45F-0195-F049-292D08E9B4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3A5414-16FB-08F1-C56F-A92909ABA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C2354-642A-4046-BEB0-DFD3439D96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4680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51D576-0E4C-CB7B-D143-C89F03784B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CC5D7B-EA79-14C1-4AD0-86567AB1EEE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95F8ED-6511-A91F-DEED-23EF83868D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79029-DFE4-244A-8A88-9AB034AAA29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04E236-D22A-2A7A-3734-BB2F82AB5F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F98182-0325-F686-DD3B-093218C587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C2354-642A-4046-BEB0-DFD3439D96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2975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592A5F-5A8B-9D51-87FF-5434AA68FE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E9C4A8-9EC7-5C5F-276C-4E9F89C3D7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7307F6-A66A-66B4-C698-7ABDDA171A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79029-DFE4-244A-8A88-9AB034AAA29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A7733C-0ECB-67AB-7A29-237AC7815A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0ACAAD-BA72-AF5E-5BAD-B589B6441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C2354-642A-4046-BEB0-DFD3439D96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578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732AC-5A5E-0705-3219-6F2C8CD6D7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57F833-3D7D-E72E-6D08-B8DC6DC72E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9AF681-AD7C-AE87-C1E1-EFE3E8B571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2C15B8-B2BF-DA8D-B761-350023E7C8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79029-DFE4-244A-8A88-9AB034AAA29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93AA91-E324-BA99-8228-3034821AE7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8E7121-0C4E-D6D5-0750-1DC2E75E6A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C2354-642A-4046-BEB0-DFD3439D96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1941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17EDA0-B491-42F6-5C74-F7E97380A5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763DA1-F30E-AB80-334A-0E5583AAB9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8A2705-411C-C56D-409A-C587B00221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5FC0BC1-5FD8-5138-759F-1DAF0A33FC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F0541D7-8E3A-9F73-5F74-2E305F9DFD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2F745B4-C551-71E4-5299-880C61E0C0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79029-DFE4-244A-8A88-9AB034AAA29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4854BBB-B954-342F-586E-E1C270878E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17C7481-433B-CF5C-9561-F0E819B693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C2354-642A-4046-BEB0-DFD3439D96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4224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2C0A82-8C6C-156B-75B6-A0AB9E7094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FCCE1B5-4939-E354-D40D-0A86C24844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79029-DFE4-244A-8A88-9AB034AAA29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29B63EC-4F6A-851D-1CE4-1B7F24C6D0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0B8C42E-E40C-7DE4-D3FC-5184108F37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C2354-642A-4046-BEB0-DFD3439D96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6263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F726EEE-CFED-3D2C-93E6-2D1CD5AE6C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79029-DFE4-244A-8A88-9AB034AAA29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C7068AF-224C-CC40-2522-4AED9FA55C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C7609EC-A89C-2F84-A452-E3DA88A3F7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C2354-642A-4046-BEB0-DFD3439D96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52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A66F57-813B-38F9-F999-4F2C3BBBF2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00A56B-5CFA-9BD8-7A1D-FFB1CD67ED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C6E7611-9286-3199-C8AB-F17227B175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68A62F-8E58-3A74-CF1D-04804350B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79029-DFE4-244A-8A88-9AB034AAA29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B7E01A-4DAC-3892-EFD3-045DC7B582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58DDA5-EAB0-B27E-2C6D-8D61EFBF2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C2354-642A-4046-BEB0-DFD3439D96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650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EF4780-B491-BAD0-E051-57511D1E64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2A6BC4F-C8E8-D979-39A0-7DE777F34E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FF01EB5-F83B-89AC-E91C-BE67C2E6E4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C269CC-C32D-611F-FBCA-FAE233EB7C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579029-DFE4-244A-8A88-9AB034AAA29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DF9B7A-B531-6DDA-A19A-F4D4F1F118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85DA43-5085-6ABC-F255-E5C215BB73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8C2354-642A-4046-BEB0-DFD3439D96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044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23328CA-B691-8E23-9E80-75794B7144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AB5654-B6C4-3AAF-9B08-0A4A1BFFC0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A6CFDC-9B4C-FBF0-C455-0548F79B420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579029-DFE4-244A-8A88-9AB034AAA294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8F13D3-C624-253C-4CC9-E2D33203371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833D16-4FBA-E5BB-03F7-271467FA57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8C2354-642A-4046-BEB0-DFD3439D96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6163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99AFD081-3EF3-4AB2-BF4A-60300E40B876}"/>
              </a:ext>
            </a:extLst>
          </p:cNvPr>
          <p:cNvGraphicFramePr>
            <a:graphicFrameLocks noGrp="1"/>
          </p:cNvGraphicFramePr>
          <p:nvPr/>
        </p:nvGraphicFramePr>
        <p:xfrm>
          <a:off x="2460240" y="-135644"/>
          <a:ext cx="7755178" cy="409804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015521">
                  <a:extLst>
                    <a:ext uri="{9D8B030D-6E8A-4147-A177-3AD203B41FA5}">
                      <a16:colId xmlns:a16="http://schemas.microsoft.com/office/drawing/2014/main" val="1317664448"/>
                    </a:ext>
                  </a:extLst>
                </a:gridCol>
                <a:gridCol w="2739657">
                  <a:extLst>
                    <a:ext uri="{9D8B030D-6E8A-4147-A177-3AD203B41FA5}">
                      <a16:colId xmlns:a16="http://schemas.microsoft.com/office/drawing/2014/main" val="1599689662"/>
                    </a:ext>
                  </a:extLst>
                </a:gridCol>
              </a:tblGrid>
              <a:tr h="736428">
                <a:tc gridSpan="2">
                  <a:txBody>
                    <a:bodyPr/>
                    <a:lstStyle/>
                    <a:p>
                      <a:pPr algn="l"/>
                      <a:r>
                        <a:rPr lang="en-US" sz="1100" b="1" dirty="0"/>
                        <a:t>Supplementary Table 1. </a:t>
                      </a:r>
                      <a:r>
                        <a:rPr lang="en-US" sz="1100" b="0" dirty="0"/>
                        <a:t>Summary of Partial Treatment Response to Lorazepam and Clinical Response</a:t>
                      </a:r>
                      <a:endParaRPr lang="en-US" sz="1100" b="1" dirty="0"/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en-US" sz="1000" b="1" dirty="0"/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8143961"/>
                  </a:ext>
                </a:extLst>
              </a:tr>
              <a:tr h="325424">
                <a:tc gridSpan="2">
                  <a:txBody>
                    <a:bodyPr/>
                    <a:lstStyle/>
                    <a:p>
                      <a:pPr algn="ctr"/>
                      <a:r>
                        <a:rPr lang="en-US" sz="1100" b="1" i="1" dirty="0"/>
                        <a:t>Summary of Patients with Partial Treatment Response to Lorazepa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b="1" i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61353497"/>
                  </a:ext>
                </a:extLst>
              </a:tr>
              <a:tr h="341869">
                <a:tc>
                  <a:txBody>
                    <a:bodyPr/>
                    <a:lstStyle/>
                    <a:p>
                      <a:pPr algn="l"/>
                      <a:r>
                        <a:rPr lang="en-US" sz="1100" b="0" i="0" dirty="0"/>
                        <a:t>Total number of patients with partial response to lorazepa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/>
                        <a:t>25/31 (81%)</a:t>
                      </a:r>
                      <a:endParaRPr lang="en-US" sz="1100" dirty="0">
                        <a:effectLst/>
                      </a:endParaRP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994381"/>
                  </a:ext>
                </a:extLst>
              </a:tr>
              <a:tr h="540779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Mean and median lorazepam total daily dosage for all patient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/>
                        <a:t>Mean = 6.8 mg, Median = 6.0 mg </a:t>
                      </a:r>
                    </a:p>
                    <a:p>
                      <a:pPr algn="ctr" fontAlgn="t"/>
                      <a:r>
                        <a:rPr lang="en-US" sz="1100" dirty="0"/>
                        <a:t>(Min = 0.5 mg, Max = 40 mg, </a:t>
                      </a:r>
                      <a:r>
                        <a:rPr lang="en-US" sz="1100" dirty="0">
                          <a:effectLst/>
                        </a:rPr>
                        <a:t>SD</a:t>
                      </a:r>
                      <a:r>
                        <a:rPr lang="en-US" sz="1100" dirty="0"/>
                        <a:t> =8.3)</a:t>
                      </a:r>
                      <a:endParaRPr lang="en-US" sz="1100" dirty="0">
                        <a:effectLst/>
                      </a:endParaRP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69660479"/>
                  </a:ext>
                </a:extLst>
              </a:tr>
              <a:tr h="535993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Total number of patients who experienced breakthrough symptoms when next dose of lorazepam was du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13/31 (42%)</a:t>
                      </a:r>
                      <a:endParaRPr lang="en-US" sz="1100" dirty="0">
                        <a:effectLst/>
                      </a:endParaRP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19422587"/>
                  </a:ext>
                </a:extLst>
              </a:tr>
              <a:tr h="540779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Mean and median lorazepam total daily dosage for patients with breakthrough symptomolog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/>
                        <a:t>Mean = 9.1 mg, Median = 7.0 mg </a:t>
                      </a:r>
                    </a:p>
                    <a:p>
                      <a:pPr algn="ctr" fontAlgn="t"/>
                      <a:r>
                        <a:rPr lang="en-US" sz="1100" dirty="0"/>
                        <a:t>(Min = 0.75 mg, Max = 40 mg, </a:t>
                      </a:r>
                      <a:r>
                        <a:rPr lang="en-US" sz="1100" dirty="0">
                          <a:effectLst/>
                        </a:rPr>
                        <a:t>SD</a:t>
                      </a:r>
                      <a:r>
                        <a:rPr lang="en-US" sz="1100" dirty="0"/>
                        <a:t> =10.2</a:t>
                      </a:r>
                      <a:endParaRPr lang="en-US" sz="1100" dirty="0">
                        <a:effectLst/>
                      </a:endParaRP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60368443"/>
                  </a:ext>
                </a:extLst>
              </a:tr>
              <a:tr h="535993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Total number of patients who had no clinical improvement with lorazepa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/>
                        <a:t>11/31 (35%)</a:t>
                      </a:r>
                      <a:endParaRPr lang="en-US" sz="1100" dirty="0">
                        <a:effectLst/>
                      </a:endParaRPr>
                    </a:p>
                  </a:txBody>
                  <a:tcPr marL="47625" marR="47625" marT="47625" marB="47625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39162045"/>
                  </a:ext>
                </a:extLst>
              </a:tr>
              <a:tr h="540779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Mean and median lorazepam total daily dosage for patients who had no clinical improvement with lorazepa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/>
                        <a:t>Mean = 4.0 mg, Median = 4.0 mg </a:t>
                      </a:r>
                    </a:p>
                    <a:p>
                      <a:pPr algn="ctr" fontAlgn="t"/>
                      <a:r>
                        <a:rPr lang="en-US" sz="1100" dirty="0"/>
                        <a:t>(Min = 0.5 mg, Max = 8 mg, </a:t>
                      </a:r>
                      <a:r>
                        <a:rPr lang="en-US" sz="1100" dirty="0">
                          <a:effectLst/>
                        </a:rPr>
                        <a:t>SD</a:t>
                      </a:r>
                      <a:r>
                        <a:rPr lang="en-US" sz="1100" dirty="0"/>
                        <a:t> = 3.0</a:t>
                      </a:r>
                      <a:endParaRPr lang="en-US" sz="1100" dirty="0">
                        <a:effectLst/>
                      </a:endParaRP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0475975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246979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9</Words>
  <Application>Microsoft Macintosh PowerPoint</Application>
  <PresentationFormat>Widescreen</PresentationFormat>
  <Paragraphs>1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mith, Joshua Ryan</dc:creator>
  <cp:lastModifiedBy>Smith, Joshua Ryan</cp:lastModifiedBy>
  <cp:revision>1</cp:revision>
  <dcterms:created xsi:type="dcterms:W3CDTF">2023-04-12T21:15:42Z</dcterms:created>
  <dcterms:modified xsi:type="dcterms:W3CDTF">2023-04-12T21:16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792c8cef-6f2b-4af1-b4ac-d815ff795cd6_Enabled">
    <vt:lpwstr>true</vt:lpwstr>
  </property>
  <property fmtid="{D5CDD505-2E9C-101B-9397-08002B2CF9AE}" pid="3" name="MSIP_Label_792c8cef-6f2b-4af1-b4ac-d815ff795cd6_SetDate">
    <vt:lpwstr>2023-04-12T21:16:01Z</vt:lpwstr>
  </property>
  <property fmtid="{D5CDD505-2E9C-101B-9397-08002B2CF9AE}" pid="4" name="MSIP_Label_792c8cef-6f2b-4af1-b4ac-d815ff795cd6_Method">
    <vt:lpwstr>Standard</vt:lpwstr>
  </property>
  <property fmtid="{D5CDD505-2E9C-101B-9397-08002B2CF9AE}" pid="5" name="MSIP_Label_792c8cef-6f2b-4af1-b4ac-d815ff795cd6_Name">
    <vt:lpwstr>VUMC General</vt:lpwstr>
  </property>
  <property fmtid="{D5CDD505-2E9C-101B-9397-08002B2CF9AE}" pid="6" name="MSIP_Label_792c8cef-6f2b-4af1-b4ac-d815ff795cd6_SiteId">
    <vt:lpwstr>ef575030-1424-4ed8-b83c-12c533d879ab</vt:lpwstr>
  </property>
  <property fmtid="{D5CDD505-2E9C-101B-9397-08002B2CF9AE}" pid="7" name="MSIP_Label_792c8cef-6f2b-4af1-b4ac-d815ff795cd6_ActionId">
    <vt:lpwstr>7d88b305-f40b-4161-be5f-8a1216f2c56f</vt:lpwstr>
  </property>
  <property fmtid="{D5CDD505-2E9C-101B-9397-08002B2CF9AE}" pid="8" name="MSIP_Label_792c8cef-6f2b-4af1-b4ac-d815ff795cd6_ContentBits">
    <vt:lpwstr>0</vt:lpwstr>
  </property>
</Properties>
</file>